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24" autoAdjust="0"/>
    <p:restoredTop sz="94660"/>
  </p:normalViewPr>
  <p:slideViewPr>
    <p:cSldViewPr snapToGrid="0">
      <p:cViewPr varScale="1">
        <p:scale>
          <a:sx n="101" d="100"/>
          <a:sy n="101" d="100"/>
        </p:scale>
        <p:origin x="138" y="13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C31B7D-D0AB-4D95-B79A-F31A547DE08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D37A9E4-D176-4AD1-8DCE-5541C82B5FE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72C903-EC15-48F3-9D82-01EF1EC848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E91C7-D323-48E4-A784-99AFFCAE6B88}" type="datetimeFigureOut">
              <a:rPr lang="en-AU" smtClean="0"/>
              <a:t>4/12/2020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79A54E-1B6A-4641-AD0C-44DABA215D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AA9023-E9DB-4592-B58A-03846597A5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DF5EF-9A37-4329-A8C8-B235DEFFAF9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136394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4AA47C-B57B-4AE7-B96C-F0811CD99B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2AAF6AA-12B7-48F1-B095-2B381F051C0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32A51D-449E-44F5-91C9-F2B3E8F460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E91C7-D323-48E4-A784-99AFFCAE6B88}" type="datetimeFigureOut">
              <a:rPr lang="en-AU" smtClean="0"/>
              <a:t>4/12/2020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80655F-A3C4-4C31-AE48-C9498DF5BE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3E1EF5-F245-4CFB-BB8C-CFC380DCE3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DF5EF-9A37-4329-A8C8-B235DEFFAF9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874210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6D653AA-D9C2-4DBB-A505-3E6110ED14B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7A8A3F6-9633-4893-9068-776D56E9CC8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7952F5-20F8-4784-B075-170EB812E2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E91C7-D323-48E4-A784-99AFFCAE6B88}" type="datetimeFigureOut">
              <a:rPr lang="en-AU" smtClean="0"/>
              <a:t>4/12/2020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8C237F-7D6B-4511-AAB2-CEA5534D55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55AAAF-37E4-4B41-B6E8-4A8EC2AFB0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DF5EF-9A37-4329-A8C8-B235DEFFAF9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808782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39495D-DAD1-4477-A1A8-AF39FD869F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A5CF3FD-3970-4549-8EDE-71EE246D206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5B2170-30D2-4F58-A0B4-EF4BA68340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E91C7-D323-48E4-A784-99AFFCAE6B88}" type="datetimeFigureOut">
              <a:rPr lang="en-AU" smtClean="0"/>
              <a:t>4/12/2020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4C3576-3BD2-4F58-8761-C763C2A294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C4435A-5328-4AA3-9B14-039D41BEBE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DF5EF-9A37-4329-A8C8-B235DEFFAF9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469588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23196E-5F25-4832-9887-2B654416F4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46D2C59-C528-4C32-9A05-A531500E57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3DE429-202C-4F93-8BAD-BCA275A6E1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E91C7-D323-48E4-A784-99AFFCAE6B88}" type="datetimeFigureOut">
              <a:rPr lang="en-AU" smtClean="0"/>
              <a:t>4/12/2020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396E70-C78F-4CC1-87DB-A2E2FDAD93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4BC2D3-06EC-42C0-B21C-17157160AA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DF5EF-9A37-4329-A8C8-B235DEFFAF9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614301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5976B8-2721-4B4C-BC09-44567E47A0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0CA5C9A-1A67-412F-BC83-524E1FAC677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F37470E-3D64-4C65-BB90-FAB85B7E22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44082B3-6E9E-41F0-9D21-E5F1FE6FD0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E91C7-D323-48E4-A784-99AFFCAE6B88}" type="datetimeFigureOut">
              <a:rPr lang="en-AU" smtClean="0"/>
              <a:t>4/12/2020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8EBEDA7-C573-4303-9610-4334135D85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7A63EE2-E0D3-4E70-8185-B1503701FE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DF5EF-9A37-4329-A8C8-B235DEFFAF9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398921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0B1EC7-D0F7-445A-8F97-338C128723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1E5A723-65A5-4DF4-8FFC-7045EC61EA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4317ADF-E0E5-4D31-AC6B-CF2548F3E88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9F6EE12-E1C4-47B4-9EB6-D9206FE229A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A333E26-A75C-4F69-9689-DF3CAB1AFC1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0F0F778-75B5-492B-8A2F-459178A02B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E91C7-D323-48E4-A784-99AFFCAE6B88}" type="datetimeFigureOut">
              <a:rPr lang="en-AU" smtClean="0"/>
              <a:t>4/12/2020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7A5EB3A-EBF1-40E1-8364-F6CAB7AFE3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C7F234A-DC2E-4DB7-A77B-6354B83BD4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DF5EF-9A37-4329-A8C8-B235DEFFAF9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179029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3275BC-53B6-4874-B595-81475781E1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E4F38B3-C3F3-48AC-B005-DB842F3B61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E91C7-D323-48E4-A784-99AFFCAE6B88}" type="datetimeFigureOut">
              <a:rPr lang="en-AU" smtClean="0"/>
              <a:t>4/12/2020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8540B77-40AA-4044-9BBD-642F5E7162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BD68CAD-44C4-43E7-A3CE-4440FF38D2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DF5EF-9A37-4329-A8C8-B235DEFFAF9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724430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0D4D432-0208-4F0B-B174-EAC381C9FF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E91C7-D323-48E4-A784-99AFFCAE6B88}" type="datetimeFigureOut">
              <a:rPr lang="en-AU" smtClean="0"/>
              <a:t>4/12/2020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527741B-3A79-43C3-B12B-35C4CC1F53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F4692AB-30BC-4AEC-82B0-F69D731A41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DF5EF-9A37-4329-A8C8-B235DEFFAF9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367511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CD72E0-1844-4CC7-9DF9-A8F632B7B4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1C4C8DE-CC88-4A60-A758-3B0B11A154C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BBA3214-EDE2-4C0F-8C11-A107FA2516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A6A4A19-80E6-44B6-8470-F3D89546B4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E91C7-D323-48E4-A784-99AFFCAE6B88}" type="datetimeFigureOut">
              <a:rPr lang="en-AU" smtClean="0"/>
              <a:t>4/12/2020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1375CF2-4D71-457F-84EB-507EDDDAD9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E4A4746-6734-4A1E-8EE6-4B033A6BF3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DF5EF-9A37-4329-A8C8-B235DEFFAF9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548714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AEDB49-D020-4369-B47E-15956D1FD2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E0CD836-1A62-4FF6-8774-6D7C182AB67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5B47ACF-6227-4351-A48D-F7C3E2AF1B4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4515DFC-CEEB-4C94-95F3-AB33BEC1A1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E91C7-D323-48E4-A784-99AFFCAE6B88}" type="datetimeFigureOut">
              <a:rPr lang="en-AU" smtClean="0"/>
              <a:t>4/12/2020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30111AB-9D86-4D2C-A0C1-E9649413D6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1782148-C9B5-43FD-9757-36A6B1C137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DF5EF-9A37-4329-A8C8-B235DEFFAF9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778560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24122C5-D153-4E81-9F70-88B870F0D4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49D08A8-A1D4-4C58-9C7D-342A71538E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7B58A7-4D39-40B1-AAB3-E62EBEB5AE6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DE91C7-D323-48E4-A784-99AFFCAE6B88}" type="datetimeFigureOut">
              <a:rPr lang="en-AU" smtClean="0"/>
              <a:t>4/12/2020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3927B3-737D-464F-9E80-87AA90D77EC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770D38-E72C-4655-B61A-CB59BA88DFD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2DF5EF-9A37-4329-A8C8-B235DEFFAF9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557525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10EF44C-1855-4B9D-B9FA-D170F2E1AD53}"/>
              </a:ext>
            </a:extLst>
          </p:cNvPr>
          <p:cNvSpPr txBox="1"/>
          <p:nvPr/>
        </p:nvSpPr>
        <p:spPr>
          <a:xfrm>
            <a:off x="6638004" y="5495607"/>
            <a:ext cx="163209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CexE</a:t>
            </a:r>
            <a:endParaRPr lang="en-AU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BD066667-E5A1-4D3A-B722-42954AA3F308}"/>
              </a:ext>
            </a:extLst>
          </p:cNvPr>
          <p:cNvCxnSpPr>
            <a:cxnSpLocks/>
          </p:cNvCxnSpPr>
          <p:nvPr/>
        </p:nvCxnSpPr>
        <p:spPr>
          <a:xfrm>
            <a:off x="6509794" y="5726439"/>
            <a:ext cx="180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" name="Picture 5" descr="A close up of a computer&#10;&#10;Description automatically generated">
            <a:extLst>
              <a:ext uri="{FF2B5EF4-FFF2-40B4-BE49-F238E27FC236}">
                <a16:creationId xmlns:a16="http://schemas.microsoft.com/office/drawing/2014/main" id="{54DE5940-2AD2-4ADD-ADFD-D09830EA8F9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-914" t="4999" r="1967" b="1574"/>
          <a:stretch/>
        </p:blipFill>
        <p:spPr>
          <a:xfrm>
            <a:off x="3018415" y="1762125"/>
            <a:ext cx="5963659" cy="4955371"/>
          </a:xfrm>
          <a:prstGeom prst="rect">
            <a:avLst/>
          </a:prstGeom>
          <a:ln w="25400">
            <a:noFill/>
          </a:ln>
        </p:spPr>
      </p:pic>
      <p:graphicFrame>
        <p:nvGraphicFramePr>
          <p:cNvPr id="19" name="Table 6">
            <a:extLst>
              <a:ext uri="{FF2B5EF4-FFF2-40B4-BE49-F238E27FC236}">
                <a16:creationId xmlns:a16="http://schemas.microsoft.com/office/drawing/2014/main" id="{585CF52E-14A9-494C-BB01-ED34BE93533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40724586"/>
              </p:ext>
            </p:extLst>
          </p:nvPr>
        </p:nvGraphicFramePr>
        <p:xfrm>
          <a:off x="6313013" y="900728"/>
          <a:ext cx="4760844" cy="110451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90609">
                  <a:extLst>
                    <a:ext uri="{9D8B030D-6E8A-4147-A177-3AD203B41FA5}">
                      <a16:colId xmlns:a16="http://schemas.microsoft.com/office/drawing/2014/main" val="1399428744"/>
                    </a:ext>
                  </a:extLst>
                </a:gridCol>
                <a:gridCol w="490609">
                  <a:extLst>
                    <a:ext uri="{9D8B030D-6E8A-4147-A177-3AD203B41FA5}">
                      <a16:colId xmlns:a16="http://schemas.microsoft.com/office/drawing/2014/main" val="2505094533"/>
                    </a:ext>
                  </a:extLst>
                </a:gridCol>
                <a:gridCol w="490609">
                  <a:extLst>
                    <a:ext uri="{9D8B030D-6E8A-4147-A177-3AD203B41FA5}">
                      <a16:colId xmlns:a16="http://schemas.microsoft.com/office/drawing/2014/main" val="1591287173"/>
                    </a:ext>
                  </a:extLst>
                </a:gridCol>
                <a:gridCol w="490609">
                  <a:extLst>
                    <a:ext uri="{9D8B030D-6E8A-4147-A177-3AD203B41FA5}">
                      <a16:colId xmlns:a16="http://schemas.microsoft.com/office/drawing/2014/main" val="1803725747"/>
                    </a:ext>
                  </a:extLst>
                </a:gridCol>
                <a:gridCol w="2798408">
                  <a:extLst>
                    <a:ext uri="{9D8B030D-6E8A-4147-A177-3AD203B41FA5}">
                      <a16:colId xmlns:a16="http://schemas.microsoft.com/office/drawing/2014/main" val="2367352999"/>
                    </a:ext>
                  </a:extLst>
                </a:gridCol>
              </a:tblGrid>
              <a:tr h="552257">
                <a:tc>
                  <a:txBody>
                    <a:bodyPr/>
                    <a:lstStyle/>
                    <a:p>
                      <a:pPr algn="ctr"/>
                      <a:r>
                        <a:rPr lang="en-AU" sz="14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‒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4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‒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79998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4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79998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AU" sz="1600" b="0" i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% L-arabinose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35247367"/>
                  </a:ext>
                </a:extLst>
              </a:tr>
              <a:tr h="552257">
                <a:tc>
                  <a:txBody>
                    <a:bodyPr/>
                    <a:lstStyle/>
                    <a:p>
                      <a:pPr algn="ctr"/>
                      <a:r>
                        <a:rPr lang="en-AU" sz="14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‒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4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‒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79998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‒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79998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AU" sz="1600" b="0" i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 mM </a:t>
                      </a:r>
                      <a:r>
                        <a:rPr lang="en-AU" sz="1600" b="0" i="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zide</a:t>
                      </a:r>
                      <a:endParaRPr lang="en-AU" sz="1600" b="0" i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7200309"/>
                  </a:ext>
                </a:extLst>
              </a:tr>
            </a:tbl>
          </a:graphicData>
        </a:graphic>
      </p:graphicFrame>
      <p:sp>
        <p:nvSpPr>
          <p:cNvPr id="20" name="TextBox 19">
            <a:extLst>
              <a:ext uri="{FF2B5EF4-FFF2-40B4-BE49-F238E27FC236}">
                <a16:creationId xmlns:a16="http://schemas.microsoft.com/office/drawing/2014/main" id="{DB656F4D-F5C4-4FC0-B0DB-D7BAC5D88A07}"/>
              </a:ext>
            </a:extLst>
          </p:cNvPr>
          <p:cNvSpPr txBox="1"/>
          <p:nvPr/>
        </p:nvSpPr>
        <p:spPr>
          <a:xfrm>
            <a:off x="5662" y="105667"/>
            <a:ext cx="503195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hole cell lysate – anti-RNAP western</a:t>
            </a:r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id="{947D5C59-2568-45CB-96EC-FD0F22A83D82}"/>
              </a:ext>
            </a:extLst>
          </p:cNvPr>
          <p:cNvGrpSpPr/>
          <p:nvPr/>
        </p:nvGrpSpPr>
        <p:grpSpPr>
          <a:xfrm>
            <a:off x="2719793" y="5195050"/>
            <a:ext cx="397773" cy="261610"/>
            <a:chOff x="1393024" y="3367982"/>
            <a:chExt cx="397773" cy="261610"/>
          </a:xfrm>
        </p:grpSpPr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E071C712-25BD-44F5-B788-1E339F3A95FD}"/>
                </a:ext>
              </a:extLst>
            </p:cNvPr>
            <p:cNvSpPr txBox="1"/>
            <p:nvPr/>
          </p:nvSpPr>
          <p:spPr>
            <a:xfrm>
              <a:off x="1393024" y="3367982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</a:p>
          </p:txBody>
        </p:sp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id="{0C08D66C-B504-441C-B0E8-61A100962A55}"/>
                </a:ext>
              </a:extLst>
            </p:cNvPr>
            <p:cNvCxnSpPr/>
            <p:nvPr/>
          </p:nvCxnSpPr>
          <p:spPr>
            <a:xfrm flipH="1">
              <a:off x="1644130" y="3495602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id="{D69982CE-B6B9-4BDE-A2EF-4D4EA0ADBF5F}"/>
              </a:ext>
            </a:extLst>
          </p:cNvPr>
          <p:cNvGrpSpPr/>
          <p:nvPr/>
        </p:nvGrpSpPr>
        <p:grpSpPr>
          <a:xfrm>
            <a:off x="2719793" y="4434401"/>
            <a:ext cx="397773" cy="261610"/>
            <a:chOff x="1311020" y="3006632"/>
            <a:chExt cx="397773" cy="261610"/>
          </a:xfrm>
        </p:grpSpPr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EC841B6A-ABA7-4F19-8D80-13035FA43DC3}"/>
                </a:ext>
              </a:extLst>
            </p:cNvPr>
            <p:cNvSpPr txBox="1"/>
            <p:nvPr/>
          </p:nvSpPr>
          <p:spPr>
            <a:xfrm>
              <a:off x="1311020" y="3006632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</a:p>
          </p:txBody>
        </p:sp>
        <p:cxnSp>
          <p:nvCxnSpPr>
            <p:cNvPr id="26" name="Straight Connector 25">
              <a:extLst>
                <a:ext uri="{FF2B5EF4-FFF2-40B4-BE49-F238E27FC236}">
                  <a16:creationId xmlns:a16="http://schemas.microsoft.com/office/drawing/2014/main" id="{BD420AE3-5C0A-460B-99AB-611167D862D6}"/>
                </a:ext>
              </a:extLst>
            </p:cNvPr>
            <p:cNvCxnSpPr/>
            <p:nvPr/>
          </p:nvCxnSpPr>
          <p:spPr>
            <a:xfrm flipH="1">
              <a:off x="1562126" y="3137437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7" name="Group 26">
            <a:extLst>
              <a:ext uri="{FF2B5EF4-FFF2-40B4-BE49-F238E27FC236}">
                <a16:creationId xmlns:a16="http://schemas.microsoft.com/office/drawing/2014/main" id="{765BCA02-D6A7-42A8-A0D4-107BFCB26072}"/>
              </a:ext>
            </a:extLst>
          </p:cNvPr>
          <p:cNvGrpSpPr/>
          <p:nvPr/>
        </p:nvGrpSpPr>
        <p:grpSpPr>
          <a:xfrm>
            <a:off x="2719793" y="4118802"/>
            <a:ext cx="397773" cy="261610"/>
            <a:chOff x="1311020" y="2832922"/>
            <a:chExt cx="397773" cy="261610"/>
          </a:xfrm>
        </p:grpSpPr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6EBBE681-837F-4EC1-9C76-85678DD908C8}"/>
                </a:ext>
              </a:extLst>
            </p:cNvPr>
            <p:cNvSpPr txBox="1"/>
            <p:nvPr/>
          </p:nvSpPr>
          <p:spPr>
            <a:xfrm>
              <a:off x="1311020" y="2832922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</a:t>
              </a:r>
            </a:p>
          </p:txBody>
        </p:sp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id="{4CDA85E6-0522-4068-8B0C-13E4798B4FCF}"/>
                </a:ext>
              </a:extLst>
            </p:cNvPr>
            <p:cNvCxnSpPr/>
            <p:nvPr/>
          </p:nvCxnSpPr>
          <p:spPr>
            <a:xfrm flipH="1">
              <a:off x="1562126" y="2964744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0" name="Group 29">
            <a:extLst>
              <a:ext uri="{FF2B5EF4-FFF2-40B4-BE49-F238E27FC236}">
                <a16:creationId xmlns:a16="http://schemas.microsoft.com/office/drawing/2014/main" id="{BECD8D17-BFAB-4D4D-B9B7-70AE9BE0A87F}"/>
              </a:ext>
            </a:extLst>
          </p:cNvPr>
          <p:cNvGrpSpPr/>
          <p:nvPr/>
        </p:nvGrpSpPr>
        <p:grpSpPr>
          <a:xfrm>
            <a:off x="2719793" y="3671527"/>
            <a:ext cx="392534" cy="261610"/>
            <a:chOff x="1316259" y="2597742"/>
            <a:chExt cx="392534" cy="261610"/>
          </a:xfrm>
        </p:grpSpPr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214A96BC-0A89-4E68-BAF1-D2A0C95F2FA8}"/>
                </a:ext>
              </a:extLst>
            </p:cNvPr>
            <p:cNvSpPr txBox="1"/>
            <p:nvPr/>
          </p:nvSpPr>
          <p:spPr>
            <a:xfrm>
              <a:off x="1316259" y="2597742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</a:p>
          </p:txBody>
        </p:sp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41B4A79A-25F8-443A-BF1B-42A04590AD0C}"/>
                </a:ext>
              </a:extLst>
            </p:cNvPr>
            <p:cNvCxnSpPr/>
            <p:nvPr/>
          </p:nvCxnSpPr>
          <p:spPr>
            <a:xfrm flipH="1">
              <a:off x="1562126" y="2728547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3" name="Group 32">
            <a:extLst>
              <a:ext uri="{FF2B5EF4-FFF2-40B4-BE49-F238E27FC236}">
                <a16:creationId xmlns:a16="http://schemas.microsoft.com/office/drawing/2014/main" id="{2127A9DC-4EE8-45A4-B509-AB5EBBF6A684}"/>
              </a:ext>
            </a:extLst>
          </p:cNvPr>
          <p:cNvGrpSpPr/>
          <p:nvPr/>
        </p:nvGrpSpPr>
        <p:grpSpPr>
          <a:xfrm>
            <a:off x="2719793" y="3331865"/>
            <a:ext cx="392534" cy="261610"/>
            <a:chOff x="1316259" y="2425509"/>
            <a:chExt cx="392534" cy="261610"/>
          </a:xfrm>
        </p:grpSpPr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9AF2216D-A8F2-465B-94BB-45447DB4F804}"/>
                </a:ext>
              </a:extLst>
            </p:cNvPr>
            <p:cNvSpPr txBox="1"/>
            <p:nvPr/>
          </p:nvSpPr>
          <p:spPr>
            <a:xfrm>
              <a:off x="1316259" y="2425509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5</a:t>
              </a:r>
            </a:p>
          </p:txBody>
        </p:sp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1247E521-EB4B-40F6-AE4F-ED3250D6FF32}"/>
                </a:ext>
              </a:extLst>
            </p:cNvPr>
            <p:cNvCxnSpPr/>
            <p:nvPr/>
          </p:nvCxnSpPr>
          <p:spPr>
            <a:xfrm flipH="1">
              <a:off x="1562126" y="2557133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6" name="Group 35">
            <a:extLst>
              <a:ext uri="{FF2B5EF4-FFF2-40B4-BE49-F238E27FC236}">
                <a16:creationId xmlns:a16="http://schemas.microsoft.com/office/drawing/2014/main" id="{E5518278-5FD1-4327-8A57-F215801A0638}"/>
              </a:ext>
            </a:extLst>
          </p:cNvPr>
          <p:cNvGrpSpPr/>
          <p:nvPr/>
        </p:nvGrpSpPr>
        <p:grpSpPr>
          <a:xfrm>
            <a:off x="2656838" y="2571239"/>
            <a:ext cx="455489" cy="261610"/>
            <a:chOff x="1250098" y="2063666"/>
            <a:chExt cx="455489" cy="261610"/>
          </a:xfrm>
        </p:grpSpPr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7EA8AB2C-CD21-43BB-B7D5-EEBA443E8693}"/>
                </a:ext>
              </a:extLst>
            </p:cNvPr>
            <p:cNvSpPr txBox="1"/>
            <p:nvPr/>
          </p:nvSpPr>
          <p:spPr>
            <a:xfrm>
              <a:off x="1250098" y="2063666"/>
              <a:ext cx="3962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</a:p>
          </p:txBody>
        </p:sp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id="{E63CF4C0-EBC4-4B0C-8992-82F8053CA48C}"/>
                </a:ext>
              </a:extLst>
            </p:cNvPr>
            <p:cNvCxnSpPr/>
            <p:nvPr/>
          </p:nvCxnSpPr>
          <p:spPr>
            <a:xfrm flipH="1">
              <a:off x="1558920" y="2201228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9" name="Group 38">
            <a:extLst>
              <a:ext uri="{FF2B5EF4-FFF2-40B4-BE49-F238E27FC236}">
                <a16:creationId xmlns:a16="http://schemas.microsoft.com/office/drawing/2014/main" id="{58A90890-D834-474D-8E4B-33EBB0A33933}"/>
              </a:ext>
            </a:extLst>
          </p:cNvPr>
          <p:cNvGrpSpPr/>
          <p:nvPr/>
        </p:nvGrpSpPr>
        <p:grpSpPr>
          <a:xfrm>
            <a:off x="2660473" y="2169486"/>
            <a:ext cx="455489" cy="261610"/>
            <a:chOff x="1254594" y="1899344"/>
            <a:chExt cx="455489" cy="261610"/>
          </a:xfrm>
        </p:grpSpPr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F0D670C4-22EA-4DC1-B52B-B048213E340D}"/>
                </a:ext>
              </a:extLst>
            </p:cNvPr>
            <p:cNvSpPr txBox="1"/>
            <p:nvPr/>
          </p:nvSpPr>
          <p:spPr>
            <a:xfrm>
              <a:off x="1254594" y="1899344"/>
              <a:ext cx="3962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70</a:t>
              </a:r>
            </a:p>
          </p:txBody>
        </p:sp>
        <p:cxnSp>
          <p:nvCxnSpPr>
            <p:cNvPr id="41" name="Straight Connector 40">
              <a:extLst>
                <a:ext uri="{FF2B5EF4-FFF2-40B4-BE49-F238E27FC236}">
                  <a16:creationId xmlns:a16="http://schemas.microsoft.com/office/drawing/2014/main" id="{8B09FF21-2754-418D-A0C9-F7FF55B892ED}"/>
                </a:ext>
              </a:extLst>
            </p:cNvPr>
            <p:cNvCxnSpPr/>
            <p:nvPr/>
          </p:nvCxnSpPr>
          <p:spPr>
            <a:xfrm flipH="1">
              <a:off x="1563416" y="2036906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2" name="Group 41">
            <a:extLst>
              <a:ext uri="{FF2B5EF4-FFF2-40B4-BE49-F238E27FC236}">
                <a16:creationId xmlns:a16="http://schemas.microsoft.com/office/drawing/2014/main" id="{0E71327B-5352-4144-B09E-393A9BD461D0}"/>
              </a:ext>
            </a:extLst>
          </p:cNvPr>
          <p:cNvGrpSpPr/>
          <p:nvPr/>
        </p:nvGrpSpPr>
        <p:grpSpPr>
          <a:xfrm>
            <a:off x="2656838" y="2300291"/>
            <a:ext cx="455489" cy="261610"/>
            <a:chOff x="1254594" y="1899344"/>
            <a:chExt cx="455489" cy="261610"/>
          </a:xfrm>
        </p:grpSpPr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D0D8C64F-ED20-4615-88E1-581164D90393}"/>
                </a:ext>
              </a:extLst>
            </p:cNvPr>
            <p:cNvSpPr txBox="1"/>
            <p:nvPr/>
          </p:nvSpPr>
          <p:spPr>
            <a:xfrm>
              <a:off x="1254594" y="1899344"/>
              <a:ext cx="3962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0</a:t>
              </a:r>
            </a:p>
          </p:txBody>
        </p:sp>
        <p:cxnSp>
          <p:nvCxnSpPr>
            <p:cNvPr id="44" name="Straight Connector 43">
              <a:extLst>
                <a:ext uri="{FF2B5EF4-FFF2-40B4-BE49-F238E27FC236}">
                  <a16:creationId xmlns:a16="http://schemas.microsoft.com/office/drawing/2014/main" id="{5DEFBF99-ACC8-4A2B-BB0F-96E7A3FFD88D}"/>
                </a:ext>
              </a:extLst>
            </p:cNvPr>
            <p:cNvCxnSpPr/>
            <p:nvPr/>
          </p:nvCxnSpPr>
          <p:spPr>
            <a:xfrm flipH="1">
              <a:off x="1563416" y="2036906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5" name="TextBox 44">
            <a:extLst>
              <a:ext uri="{FF2B5EF4-FFF2-40B4-BE49-F238E27FC236}">
                <a16:creationId xmlns:a16="http://schemas.microsoft.com/office/drawing/2014/main" id="{57435B47-2556-4E51-91B9-6237B3C8665A}"/>
              </a:ext>
            </a:extLst>
          </p:cNvPr>
          <p:cNvSpPr txBox="1"/>
          <p:nvPr/>
        </p:nvSpPr>
        <p:spPr>
          <a:xfrm>
            <a:off x="2527846" y="1428729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AU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6" name="Group 45">
            <a:extLst>
              <a:ext uri="{FF2B5EF4-FFF2-40B4-BE49-F238E27FC236}">
                <a16:creationId xmlns:a16="http://schemas.microsoft.com/office/drawing/2014/main" id="{9437FD87-9529-42F2-B258-6D6D45C36726}"/>
              </a:ext>
            </a:extLst>
          </p:cNvPr>
          <p:cNvGrpSpPr/>
          <p:nvPr/>
        </p:nvGrpSpPr>
        <p:grpSpPr>
          <a:xfrm>
            <a:off x="2714554" y="6083318"/>
            <a:ext cx="397773" cy="261610"/>
            <a:chOff x="1393024" y="3367982"/>
            <a:chExt cx="397773" cy="261610"/>
          </a:xfrm>
        </p:grpSpPr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F34FE51C-1616-4121-8940-C5FD9DA96C53}"/>
                </a:ext>
              </a:extLst>
            </p:cNvPr>
            <p:cNvSpPr txBox="1"/>
            <p:nvPr/>
          </p:nvSpPr>
          <p:spPr>
            <a:xfrm>
              <a:off x="1393024" y="3367982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</a:p>
          </p:txBody>
        </p:sp>
        <p:cxnSp>
          <p:nvCxnSpPr>
            <p:cNvPr id="48" name="Straight Connector 47">
              <a:extLst>
                <a:ext uri="{FF2B5EF4-FFF2-40B4-BE49-F238E27FC236}">
                  <a16:creationId xmlns:a16="http://schemas.microsoft.com/office/drawing/2014/main" id="{7A030282-2641-46AA-8674-A30925CA0DB2}"/>
                </a:ext>
              </a:extLst>
            </p:cNvPr>
            <p:cNvCxnSpPr/>
            <p:nvPr/>
          </p:nvCxnSpPr>
          <p:spPr>
            <a:xfrm flipH="1">
              <a:off x="1644130" y="3495602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49" name="Straight Arrow Connector 48">
            <a:extLst>
              <a:ext uri="{FF2B5EF4-FFF2-40B4-BE49-F238E27FC236}">
                <a16:creationId xmlns:a16="http://schemas.microsoft.com/office/drawing/2014/main" id="{0907AD51-D69B-4AF7-9845-64663219C287}"/>
              </a:ext>
            </a:extLst>
          </p:cNvPr>
          <p:cNvCxnSpPr>
            <a:cxnSpLocks/>
          </p:cNvCxnSpPr>
          <p:nvPr/>
        </p:nvCxnSpPr>
        <p:spPr>
          <a:xfrm flipH="1">
            <a:off x="9087048" y="2196961"/>
            <a:ext cx="437414" cy="0"/>
          </a:xfrm>
          <a:prstGeom prst="straightConnector1">
            <a:avLst/>
          </a:prstGeom>
          <a:ln w="2540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4242F3E0-16DD-4DC6-88A8-71E99C289280}"/>
              </a:ext>
            </a:extLst>
          </p:cNvPr>
          <p:cNvSpPr txBox="1"/>
          <p:nvPr/>
        </p:nvSpPr>
        <p:spPr>
          <a:xfrm>
            <a:off x="9524462" y="1966128"/>
            <a:ext cx="100700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NAP</a:t>
            </a:r>
          </a:p>
        </p:txBody>
      </p:sp>
      <p:cxnSp>
        <p:nvCxnSpPr>
          <p:cNvPr id="51" name="Straight Arrow Connector 50">
            <a:extLst>
              <a:ext uri="{FF2B5EF4-FFF2-40B4-BE49-F238E27FC236}">
                <a16:creationId xmlns:a16="http://schemas.microsoft.com/office/drawing/2014/main" id="{238AB78C-C240-41F9-92DA-767473533D76}"/>
              </a:ext>
            </a:extLst>
          </p:cNvPr>
          <p:cNvCxnSpPr>
            <a:cxnSpLocks/>
          </p:cNvCxnSpPr>
          <p:nvPr/>
        </p:nvCxnSpPr>
        <p:spPr>
          <a:xfrm flipH="1">
            <a:off x="9087048" y="5606064"/>
            <a:ext cx="437414" cy="0"/>
          </a:xfrm>
          <a:prstGeom prst="straightConnector1">
            <a:avLst/>
          </a:prstGeom>
          <a:ln w="2540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id="{8F731EB1-42CB-4369-94B2-23EE4B208451}"/>
              </a:ext>
            </a:extLst>
          </p:cNvPr>
          <p:cNvSpPr txBox="1"/>
          <p:nvPr/>
        </p:nvSpPr>
        <p:spPr>
          <a:xfrm>
            <a:off x="9524462" y="5375231"/>
            <a:ext cx="86754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endParaRPr lang="en-AU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920026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picture containing electronics, sitting, side, computer&#10;&#10;Description automatically generated">
            <a:extLst>
              <a:ext uri="{FF2B5EF4-FFF2-40B4-BE49-F238E27FC236}">
                <a16:creationId xmlns:a16="http://schemas.microsoft.com/office/drawing/2014/main" id="{0BE928E9-D928-420C-9274-DAE27D59951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73" t="961" r="-802" b="221"/>
          <a:stretch/>
        </p:blipFill>
        <p:spPr>
          <a:xfrm>
            <a:off x="2809876" y="1476376"/>
            <a:ext cx="6000750" cy="4857750"/>
          </a:xfrm>
          <a:prstGeom prst="rect">
            <a:avLst/>
          </a:prstGeom>
          <a:ln w="25400">
            <a:noFill/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B73CB2D3-2909-45C5-B4D7-F6752D4931EF}"/>
              </a:ext>
            </a:extLst>
          </p:cNvPr>
          <p:cNvSpPr txBox="1"/>
          <p:nvPr/>
        </p:nvSpPr>
        <p:spPr>
          <a:xfrm>
            <a:off x="5662" y="105667"/>
            <a:ext cx="490390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hole cell lysate – anti-</a:t>
            </a:r>
            <a:r>
              <a:rPr lang="en-AU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r>
              <a:rPr lang="en-AU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estern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D1EF4BD3-5F04-427E-B647-3C1E6B6F29D2}"/>
              </a:ext>
            </a:extLst>
          </p:cNvPr>
          <p:cNvGrpSpPr/>
          <p:nvPr/>
        </p:nvGrpSpPr>
        <p:grpSpPr>
          <a:xfrm>
            <a:off x="2616228" y="4949229"/>
            <a:ext cx="397773" cy="261610"/>
            <a:chOff x="1393024" y="3367982"/>
            <a:chExt cx="397773" cy="261610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3C780723-91D3-4E49-BF8F-9483B50DB9DC}"/>
                </a:ext>
              </a:extLst>
            </p:cNvPr>
            <p:cNvSpPr txBox="1"/>
            <p:nvPr/>
          </p:nvSpPr>
          <p:spPr>
            <a:xfrm>
              <a:off x="1393024" y="3367982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</a:p>
          </p:txBody>
        </p:sp>
        <p:cxnSp>
          <p:nvCxnSpPr>
            <p:cNvPr id="6" name="Straight Connector 5">
              <a:extLst>
                <a:ext uri="{FF2B5EF4-FFF2-40B4-BE49-F238E27FC236}">
                  <a16:creationId xmlns:a16="http://schemas.microsoft.com/office/drawing/2014/main" id="{9B08A1D3-0503-4B0E-AA74-F7FCC186FB91}"/>
                </a:ext>
              </a:extLst>
            </p:cNvPr>
            <p:cNvCxnSpPr/>
            <p:nvPr/>
          </p:nvCxnSpPr>
          <p:spPr>
            <a:xfrm flipH="1">
              <a:off x="1644130" y="3495602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A7E62C00-C5F6-4159-9CFA-16C29089BF68}"/>
              </a:ext>
            </a:extLst>
          </p:cNvPr>
          <p:cNvGrpSpPr/>
          <p:nvPr/>
        </p:nvGrpSpPr>
        <p:grpSpPr>
          <a:xfrm>
            <a:off x="2616228" y="4188580"/>
            <a:ext cx="397773" cy="261610"/>
            <a:chOff x="1311020" y="3006632"/>
            <a:chExt cx="397773" cy="261610"/>
          </a:xfrm>
        </p:grpSpPr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645B385E-F276-4ED3-BFC8-9B4A6A39BA06}"/>
                </a:ext>
              </a:extLst>
            </p:cNvPr>
            <p:cNvSpPr txBox="1"/>
            <p:nvPr/>
          </p:nvSpPr>
          <p:spPr>
            <a:xfrm>
              <a:off x="1311020" y="3006632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</a:p>
          </p:txBody>
        </p:sp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id="{C51F116D-F2BD-41E9-BF0A-3322CB07709F}"/>
                </a:ext>
              </a:extLst>
            </p:cNvPr>
            <p:cNvCxnSpPr/>
            <p:nvPr/>
          </p:nvCxnSpPr>
          <p:spPr>
            <a:xfrm flipH="1">
              <a:off x="1562126" y="3137437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5DFD1B7F-DBED-4E17-8BA8-80A96D2A29F5}"/>
              </a:ext>
            </a:extLst>
          </p:cNvPr>
          <p:cNvGrpSpPr/>
          <p:nvPr/>
        </p:nvGrpSpPr>
        <p:grpSpPr>
          <a:xfrm>
            <a:off x="2616228" y="3872981"/>
            <a:ext cx="397773" cy="261610"/>
            <a:chOff x="1311020" y="2832922"/>
            <a:chExt cx="397773" cy="261610"/>
          </a:xfrm>
        </p:grpSpPr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4862D152-4D21-42FA-AD8D-71D4AD704F79}"/>
                </a:ext>
              </a:extLst>
            </p:cNvPr>
            <p:cNvSpPr txBox="1"/>
            <p:nvPr/>
          </p:nvSpPr>
          <p:spPr>
            <a:xfrm>
              <a:off x="1311020" y="2832922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</a:t>
              </a:r>
            </a:p>
          </p:txBody>
        </p:sp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id="{C3E421F0-126B-497F-8081-44FB3B850975}"/>
                </a:ext>
              </a:extLst>
            </p:cNvPr>
            <p:cNvCxnSpPr/>
            <p:nvPr/>
          </p:nvCxnSpPr>
          <p:spPr>
            <a:xfrm flipH="1">
              <a:off x="1562126" y="2964744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" name="Group 12">
            <a:extLst>
              <a:ext uri="{FF2B5EF4-FFF2-40B4-BE49-F238E27FC236}">
                <a16:creationId xmlns:a16="http://schemas.microsoft.com/office/drawing/2014/main" id="{5F317A3E-0610-4EE2-BD48-4B6A2E8663E0}"/>
              </a:ext>
            </a:extLst>
          </p:cNvPr>
          <p:cNvGrpSpPr/>
          <p:nvPr/>
        </p:nvGrpSpPr>
        <p:grpSpPr>
          <a:xfrm>
            <a:off x="2616228" y="3425706"/>
            <a:ext cx="392534" cy="261610"/>
            <a:chOff x="1316259" y="2597742"/>
            <a:chExt cx="392534" cy="261610"/>
          </a:xfrm>
        </p:grpSpPr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3FEDC58E-AE9B-4AE7-9435-943608479EF7}"/>
                </a:ext>
              </a:extLst>
            </p:cNvPr>
            <p:cNvSpPr txBox="1"/>
            <p:nvPr/>
          </p:nvSpPr>
          <p:spPr>
            <a:xfrm>
              <a:off x="1316259" y="2597742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</a:p>
          </p:txBody>
        </p:sp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id="{409C2AD0-9F05-4518-BBB8-65E9B7128F2B}"/>
                </a:ext>
              </a:extLst>
            </p:cNvPr>
            <p:cNvCxnSpPr/>
            <p:nvPr/>
          </p:nvCxnSpPr>
          <p:spPr>
            <a:xfrm flipH="1">
              <a:off x="1562126" y="2728547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id="{810C4DBB-C649-44E6-840C-08ED9C0F0DB8}"/>
              </a:ext>
            </a:extLst>
          </p:cNvPr>
          <p:cNvGrpSpPr/>
          <p:nvPr/>
        </p:nvGrpSpPr>
        <p:grpSpPr>
          <a:xfrm>
            <a:off x="2616228" y="3086044"/>
            <a:ext cx="392534" cy="261610"/>
            <a:chOff x="1316259" y="2425509"/>
            <a:chExt cx="392534" cy="261610"/>
          </a:xfrm>
        </p:grpSpPr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FC2495CC-D660-49FE-923B-70E729D2BD73}"/>
                </a:ext>
              </a:extLst>
            </p:cNvPr>
            <p:cNvSpPr txBox="1"/>
            <p:nvPr/>
          </p:nvSpPr>
          <p:spPr>
            <a:xfrm>
              <a:off x="1316259" y="2425509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5</a:t>
              </a:r>
            </a:p>
          </p:txBody>
        </p:sp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09F9D24E-8147-41CB-9CA9-62C2F663AF61}"/>
                </a:ext>
              </a:extLst>
            </p:cNvPr>
            <p:cNvCxnSpPr/>
            <p:nvPr/>
          </p:nvCxnSpPr>
          <p:spPr>
            <a:xfrm flipH="1">
              <a:off x="1562126" y="2557133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9" name="Group 18">
            <a:extLst>
              <a:ext uri="{FF2B5EF4-FFF2-40B4-BE49-F238E27FC236}">
                <a16:creationId xmlns:a16="http://schemas.microsoft.com/office/drawing/2014/main" id="{EDC2ABA7-82A1-423B-B998-B0BE75E6D31E}"/>
              </a:ext>
            </a:extLst>
          </p:cNvPr>
          <p:cNvGrpSpPr/>
          <p:nvPr/>
        </p:nvGrpSpPr>
        <p:grpSpPr>
          <a:xfrm>
            <a:off x="2553273" y="2325418"/>
            <a:ext cx="455489" cy="261610"/>
            <a:chOff x="1250098" y="2063666"/>
            <a:chExt cx="455489" cy="261610"/>
          </a:xfrm>
        </p:grpSpPr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39800DFD-F34B-4410-83C8-5D91899933D0}"/>
                </a:ext>
              </a:extLst>
            </p:cNvPr>
            <p:cNvSpPr txBox="1"/>
            <p:nvPr/>
          </p:nvSpPr>
          <p:spPr>
            <a:xfrm>
              <a:off x="1250098" y="2063666"/>
              <a:ext cx="3962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</a:p>
          </p:txBody>
        </p: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922054E0-7E7D-43F8-B672-91DB77368D8A}"/>
                </a:ext>
              </a:extLst>
            </p:cNvPr>
            <p:cNvCxnSpPr/>
            <p:nvPr/>
          </p:nvCxnSpPr>
          <p:spPr>
            <a:xfrm flipH="1">
              <a:off x="1558920" y="2201228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2" name="Group 21">
            <a:extLst>
              <a:ext uri="{FF2B5EF4-FFF2-40B4-BE49-F238E27FC236}">
                <a16:creationId xmlns:a16="http://schemas.microsoft.com/office/drawing/2014/main" id="{8DD68415-AA77-4F3E-9258-867FC6D900FB}"/>
              </a:ext>
            </a:extLst>
          </p:cNvPr>
          <p:cNvGrpSpPr/>
          <p:nvPr/>
        </p:nvGrpSpPr>
        <p:grpSpPr>
          <a:xfrm>
            <a:off x="2556908" y="1923665"/>
            <a:ext cx="455489" cy="261610"/>
            <a:chOff x="1254594" y="1899344"/>
            <a:chExt cx="455489" cy="261610"/>
          </a:xfrm>
        </p:grpSpPr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C2EABAF5-4A07-4F11-B524-B780BA06F10D}"/>
                </a:ext>
              </a:extLst>
            </p:cNvPr>
            <p:cNvSpPr txBox="1"/>
            <p:nvPr/>
          </p:nvSpPr>
          <p:spPr>
            <a:xfrm>
              <a:off x="1254594" y="1899344"/>
              <a:ext cx="3962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70</a:t>
              </a:r>
            </a:p>
          </p:txBody>
        </p:sp>
        <p:cxnSp>
          <p:nvCxnSpPr>
            <p:cNvPr id="24" name="Straight Connector 23">
              <a:extLst>
                <a:ext uri="{FF2B5EF4-FFF2-40B4-BE49-F238E27FC236}">
                  <a16:creationId xmlns:a16="http://schemas.microsoft.com/office/drawing/2014/main" id="{C9EC2A25-1DC6-41E8-B6D9-FDFB0D9298C0}"/>
                </a:ext>
              </a:extLst>
            </p:cNvPr>
            <p:cNvCxnSpPr/>
            <p:nvPr/>
          </p:nvCxnSpPr>
          <p:spPr>
            <a:xfrm flipH="1">
              <a:off x="1563416" y="2036906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5" name="Group 24">
            <a:extLst>
              <a:ext uri="{FF2B5EF4-FFF2-40B4-BE49-F238E27FC236}">
                <a16:creationId xmlns:a16="http://schemas.microsoft.com/office/drawing/2014/main" id="{47D07A61-569C-4DF7-957E-55451FED7F87}"/>
              </a:ext>
            </a:extLst>
          </p:cNvPr>
          <p:cNvGrpSpPr/>
          <p:nvPr/>
        </p:nvGrpSpPr>
        <p:grpSpPr>
          <a:xfrm>
            <a:off x="2553273" y="2054470"/>
            <a:ext cx="455489" cy="261610"/>
            <a:chOff x="1254594" y="1899344"/>
            <a:chExt cx="455489" cy="261610"/>
          </a:xfrm>
        </p:grpSpPr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2E2CD3C8-C5EF-482F-B3FF-5EADA2906B8F}"/>
                </a:ext>
              </a:extLst>
            </p:cNvPr>
            <p:cNvSpPr txBox="1"/>
            <p:nvPr/>
          </p:nvSpPr>
          <p:spPr>
            <a:xfrm>
              <a:off x="1254594" y="1899344"/>
              <a:ext cx="3962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0</a:t>
              </a:r>
            </a:p>
          </p:txBody>
        </p:sp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id="{42A6BFD8-27DA-4387-BC74-ECFE4876E8B6}"/>
                </a:ext>
              </a:extLst>
            </p:cNvPr>
            <p:cNvCxnSpPr/>
            <p:nvPr/>
          </p:nvCxnSpPr>
          <p:spPr>
            <a:xfrm flipH="1">
              <a:off x="1563416" y="2036906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8" name="TextBox 27">
            <a:extLst>
              <a:ext uri="{FF2B5EF4-FFF2-40B4-BE49-F238E27FC236}">
                <a16:creationId xmlns:a16="http://schemas.microsoft.com/office/drawing/2014/main" id="{822EC247-6C52-42FA-A6CE-93DEE5A92269}"/>
              </a:ext>
            </a:extLst>
          </p:cNvPr>
          <p:cNvSpPr txBox="1"/>
          <p:nvPr/>
        </p:nvSpPr>
        <p:spPr>
          <a:xfrm>
            <a:off x="2424281" y="1182908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AU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9" name="Group 28">
            <a:extLst>
              <a:ext uri="{FF2B5EF4-FFF2-40B4-BE49-F238E27FC236}">
                <a16:creationId xmlns:a16="http://schemas.microsoft.com/office/drawing/2014/main" id="{7688D29E-AA9B-4071-84A8-71E44BCF87A3}"/>
              </a:ext>
            </a:extLst>
          </p:cNvPr>
          <p:cNvGrpSpPr/>
          <p:nvPr/>
        </p:nvGrpSpPr>
        <p:grpSpPr>
          <a:xfrm>
            <a:off x="2610989" y="5837497"/>
            <a:ext cx="397773" cy="261610"/>
            <a:chOff x="1393024" y="3367982"/>
            <a:chExt cx="397773" cy="261610"/>
          </a:xfrm>
        </p:grpSpPr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CFFEEC71-5D34-4F0A-B03B-3F5BC2868A1C}"/>
                </a:ext>
              </a:extLst>
            </p:cNvPr>
            <p:cNvSpPr txBox="1"/>
            <p:nvPr/>
          </p:nvSpPr>
          <p:spPr>
            <a:xfrm>
              <a:off x="1393024" y="3367982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</a:p>
          </p:txBody>
        </p:sp>
        <p:cxnSp>
          <p:nvCxnSpPr>
            <p:cNvPr id="31" name="Straight Connector 30">
              <a:extLst>
                <a:ext uri="{FF2B5EF4-FFF2-40B4-BE49-F238E27FC236}">
                  <a16:creationId xmlns:a16="http://schemas.microsoft.com/office/drawing/2014/main" id="{BBDD281C-DFEA-458A-BA9B-CE4D5B24371C}"/>
                </a:ext>
              </a:extLst>
            </p:cNvPr>
            <p:cNvCxnSpPr/>
            <p:nvPr/>
          </p:nvCxnSpPr>
          <p:spPr>
            <a:xfrm flipH="1">
              <a:off x="1644130" y="3495602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aphicFrame>
        <p:nvGraphicFramePr>
          <p:cNvPr id="32" name="Table 6">
            <a:extLst>
              <a:ext uri="{FF2B5EF4-FFF2-40B4-BE49-F238E27FC236}">
                <a16:creationId xmlns:a16="http://schemas.microsoft.com/office/drawing/2014/main" id="{3FDEDFF9-3EF7-4CD4-B6BF-2CC4964FBCB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91176542"/>
              </p:ext>
            </p:extLst>
          </p:nvPr>
        </p:nvGraphicFramePr>
        <p:xfrm>
          <a:off x="6096000" y="447726"/>
          <a:ext cx="4760844" cy="110451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90609">
                  <a:extLst>
                    <a:ext uri="{9D8B030D-6E8A-4147-A177-3AD203B41FA5}">
                      <a16:colId xmlns:a16="http://schemas.microsoft.com/office/drawing/2014/main" val="1399428744"/>
                    </a:ext>
                  </a:extLst>
                </a:gridCol>
                <a:gridCol w="490609">
                  <a:extLst>
                    <a:ext uri="{9D8B030D-6E8A-4147-A177-3AD203B41FA5}">
                      <a16:colId xmlns:a16="http://schemas.microsoft.com/office/drawing/2014/main" val="2505094533"/>
                    </a:ext>
                  </a:extLst>
                </a:gridCol>
                <a:gridCol w="490609">
                  <a:extLst>
                    <a:ext uri="{9D8B030D-6E8A-4147-A177-3AD203B41FA5}">
                      <a16:colId xmlns:a16="http://schemas.microsoft.com/office/drawing/2014/main" val="1591287173"/>
                    </a:ext>
                  </a:extLst>
                </a:gridCol>
                <a:gridCol w="490609">
                  <a:extLst>
                    <a:ext uri="{9D8B030D-6E8A-4147-A177-3AD203B41FA5}">
                      <a16:colId xmlns:a16="http://schemas.microsoft.com/office/drawing/2014/main" val="1803725747"/>
                    </a:ext>
                  </a:extLst>
                </a:gridCol>
                <a:gridCol w="2798408">
                  <a:extLst>
                    <a:ext uri="{9D8B030D-6E8A-4147-A177-3AD203B41FA5}">
                      <a16:colId xmlns:a16="http://schemas.microsoft.com/office/drawing/2014/main" val="2367352999"/>
                    </a:ext>
                  </a:extLst>
                </a:gridCol>
              </a:tblGrid>
              <a:tr h="552257">
                <a:tc>
                  <a:txBody>
                    <a:bodyPr/>
                    <a:lstStyle/>
                    <a:p>
                      <a:pPr algn="ctr"/>
                      <a:r>
                        <a:rPr lang="en-AU" sz="14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‒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4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‒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79998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4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79998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AU" sz="1600" b="0" i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% L-arabinose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35247367"/>
                  </a:ext>
                </a:extLst>
              </a:tr>
              <a:tr h="552257">
                <a:tc>
                  <a:txBody>
                    <a:bodyPr/>
                    <a:lstStyle/>
                    <a:p>
                      <a:pPr algn="ctr"/>
                      <a:r>
                        <a:rPr lang="en-AU" sz="14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‒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4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‒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79998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‒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79998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AU" sz="1600" b="0" i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 mM </a:t>
                      </a:r>
                      <a:r>
                        <a:rPr lang="en-AU" sz="1600" b="0" i="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zide</a:t>
                      </a:r>
                      <a:endParaRPr lang="en-AU" sz="1600" b="0" i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7200309"/>
                  </a:ext>
                </a:extLst>
              </a:tr>
            </a:tbl>
          </a:graphicData>
        </a:graphic>
      </p:graphicFrame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2DDD98EF-DE79-4917-9124-AA2A25BF7BBD}"/>
              </a:ext>
            </a:extLst>
          </p:cNvPr>
          <p:cNvCxnSpPr>
            <a:cxnSpLocks/>
          </p:cNvCxnSpPr>
          <p:nvPr/>
        </p:nvCxnSpPr>
        <p:spPr>
          <a:xfrm flipH="1">
            <a:off x="8758807" y="5441672"/>
            <a:ext cx="437414" cy="0"/>
          </a:xfrm>
          <a:prstGeom prst="straightConnector1">
            <a:avLst/>
          </a:prstGeom>
          <a:ln w="2540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02B4430C-E6D8-43F5-9D15-0E4A0392DB82}"/>
              </a:ext>
            </a:extLst>
          </p:cNvPr>
          <p:cNvSpPr txBox="1"/>
          <p:nvPr/>
        </p:nvSpPr>
        <p:spPr>
          <a:xfrm>
            <a:off x="9196221" y="5210839"/>
            <a:ext cx="86754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endParaRPr lang="en-AU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421922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64</Words>
  <Application>Microsoft Office PowerPoint</Application>
  <PresentationFormat>Widescreen</PresentationFormat>
  <Paragraphs>4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 Icke</dc:creator>
  <cp:lastModifiedBy>Chris Icke</cp:lastModifiedBy>
  <cp:revision>5</cp:revision>
  <dcterms:created xsi:type="dcterms:W3CDTF">2020-12-04T03:13:39Z</dcterms:created>
  <dcterms:modified xsi:type="dcterms:W3CDTF">2020-12-04T03:41:20Z</dcterms:modified>
</cp:coreProperties>
</file>